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notesMasterIdLst>
    <p:notesMasterId r:id="rId3"/>
  </p:notesMasterIdLst>
  <p:sldIdLst>
    <p:sldId id="266" r:id="rId2"/>
  </p:sldIdLst>
  <p:sldSz cx="9144000" cy="6858000" type="screen4x3"/>
  <p:notesSz cx="6807200" cy="9939338"/>
  <p:defaultTextStyle>
    <a:defPPr>
      <a:defRPr lang="zh-TW"/>
    </a:defPPr>
    <a:lvl1pPr marL="0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1pPr>
    <a:lvl2pPr marL="417998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2pPr>
    <a:lvl3pPr marL="835996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3pPr>
    <a:lvl4pPr marL="1253994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4pPr>
    <a:lvl5pPr marL="1671991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5pPr>
    <a:lvl6pPr marL="2089989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6pPr>
    <a:lvl7pPr marL="2507987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7pPr>
    <a:lvl8pPr marL="2925985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8pPr>
    <a:lvl9pPr marL="3343983" algn="l" defTabSz="835996" rtl="0" eaLnBrk="1" latinLnBrk="0" hangingPunct="1">
      <a:defRPr sz="164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0" autoAdjust="0"/>
    <p:restoredTop sz="95494" autoAdjust="0"/>
  </p:normalViewPr>
  <p:slideViewPr>
    <p:cSldViewPr snapToGrid="0">
      <p:cViewPr>
        <p:scale>
          <a:sx n="150" d="100"/>
          <a:sy n="150" d="100"/>
        </p:scale>
        <p:origin x="-900" y="-16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732EAF-3441-4B92-92DA-ED64F172CB7F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3013"/>
            <a:ext cx="447357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16BA7-0ED6-4DA6-B6FC-256292E45EE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8309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A16BA7-0ED6-4DA6-B6FC-256292E45EE2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7328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45312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0228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14695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1181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4995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4535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371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3156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995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40127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0152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2C14C-FDCE-48D4-877A-32A9DAE12895}" type="datetimeFigureOut">
              <a:rPr lang="zh-TW" altLang="en-US" smtClean="0"/>
              <a:t>2016/2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BA625-EA78-48A0-B670-6E115603EF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22429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5669028"/>
              </p:ext>
            </p:extLst>
          </p:nvPr>
        </p:nvGraphicFramePr>
        <p:xfrm>
          <a:off x="1609141" y="487588"/>
          <a:ext cx="5244642" cy="38766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20000"/>
                <a:gridCol w="684000"/>
                <a:gridCol w="546186"/>
                <a:gridCol w="549076"/>
                <a:gridCol w="549076"/>
                <a:gridCol w="549076"/>
                <a:gridCol w="549076"/>
                <a:gridCol w="549076"/>
                <a:gridCol w="549076"/>
              </a:tblGrid>
              <a:tr h="189542">
                <a:tc>
                  <a:txBody>
                    <a:bodyPr/>
                    <a:lstStyle/>
                    <a:p>
                      <a:endParaRPr lang="zh-TW" altLang="en-US" sz="800" dirty="0"/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/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ical</a:t>
                      </a:r>
                      <a:r>
                        <a:rPr lang="en-US" altLang="zh-TW" sz="800" baseline="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sults</a:t>
                      </a:r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9542"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toff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1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2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3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/AC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565">
                <a:tc gridSpan="4">
                  <a:txBody>
                    <a:bodyPr/>
                    <a:lstStyle/>
                    <a:p>
                      <a:r>
                        <a:rPr lang="en-US" altLang="zh-TW" sz="8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subjects</a:t>
                      </a:r>
                      <a:endParaRPr lang="zh-TW" altLang="en-US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565">
                <a:tc>
                  <a:txBody>
                    <a:bodyPr/>
                    <a:lstStyle/>
                    <a:p>
                      <a:r>
                        <a:rPr lang="en-US" altLang="zh-TW" sz="8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zh-TW" altLang="en-US" sz="8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565"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3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3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4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00051">
                <a:tc>
                  <a:txBody>
                    <a:bodyPr/>
                    <a:lstStyle/>
                    <a:p>
                      <a:r>
                        <a:rPr lang="en-US" altLang="zh-TW" sz="8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altLang="zh-TW" sz="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ange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0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0.4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2.4 to 77.8)</a:t>
                      </a: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0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5.1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.3 to 52.7)</a:t>
                      </a: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0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3.3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4.8 to 61.6)</a:t>
                      </a: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4.0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8.1 to 43.9)</a:t>
                      </a:r>
                      <a:endParaRPr lang="zh-TW" altLang="en-US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5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8.3 to 50.2)</a:t>
                      </a:r>
                      <a:endParaRPr lang="zh-TW" altLang="en-US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0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0.2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2.5 to 74.3)</a:t>
                      </a:r>
                      <a:endParaRPr lang="zh-TW" altLang="en-US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7 </a:t>
                      </a:r>
                      <a:r>
                        <a:rPr lang="en-US" altLang="zh-TW" sz="8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0.2 (22.4 to 77.8)</a:t>
                      </a:r>
                      <a:endParaRPr lang="zh-TW" altLang="en-US" sz="8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565">
                <a:tc gridSpan="3">
                  <a:txBody>
                    <a:bodyPr/>
                    <a:lstStyle/>
                    <a:p>
                      <a:r>
                        <a:rPr lang="en-US" altLang="zh-TW" sz="800" b="0" i="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logy results</a:t>
                      </a:r>
                      <a:endParaRPr lang="zh-TW" altLang="en-US" sz="800" b="0" i="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6.15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5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</a:p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zh-TW" altLang="en-US" sz="8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C-US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.54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.11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8.92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3.51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.41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3.51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IL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C-H/AGC/HSIL</a:t>
                      </a:r>
                      <a:r>
                        <a:rPr lang="en-US" altLang="zh-TW" sz="8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.57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.57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7.14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1.43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4.29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</a:p>
                    <a:p>
                      <a:r>
                        <a:rPr lang="en-US" altLang="zh-TW" sz="80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 gridSpan="4">
                  <a:txBody>
                    <a:bodyPr/>
                    <a:lstStyle/>
                    <a:p>
                      <a:r>
                        <a:rPr lang="en-US" altLang="zh-TW" sz="8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ection modality or test</a:t>
                      </a:r>
                      <a:r>
                        <a:rPr lang="en-US" altLang="zh-TW" sz="800" b="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used</a:t>
                      </a:r>
                      <a:endParaRPr lang="zh-TW" altLang="en-US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altLang="zh-TW" sz="800" dirty="0" smtClean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-HR </a:t>
                      </a:r>
                    </a:p>
                    <a:p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4.19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0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.83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</a:t>
                      </a:r>
                    </a:p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3.00)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16/18 </a:t>
                      </a:r>
                    </a:p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3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6.98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1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25.00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3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30.00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5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38.46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5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83.33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19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79.17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36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  <a:p>
                      <a:pPr marL="127000" indent="-1270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(36.00)</a:t>
                      </a:r>
                      <a:endParaRPr lang="zh-TW" sz="8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1</a:t>
                      </a:r>
                      <a:r>
                        <a:rPr lang="en-US" altLang="zh-TW" sz="800" i="1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</a:p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</a:t>
                      </a:r>
                      <a:r>
                        <a:rPr lang="en-US" altLang="zh-TW" sz="800" dirty="0" smtClean="0">
                          <a:latin typeface="標楷體" panose="03000509000000000000" pitchFamily="65" charset="-12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≦9.0</a:t>
                      </a: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3.26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5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0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1.54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3.33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1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0307">
                <a:tc>
                  <a:txBody>
                    <a:bodyPr/>
                    <a:lstStyle/>
                    <a:p>
                      <a:r>
                        <a:rPr lang="en-US" altLang="zh-TW" sz="8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582</a:t>
                      </a:r>
                      <a:r>
                        <a:rPr lang="en-US" altLang="zh-TW" sz="800" i="1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</a:p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smtClean="0"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altLang="zh-TW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</a:t>
                      </a:r>
                      <a:r>
                        <a:rPr lang="en-US" altLang="zh-TW" sz="800" dirty="0" smtClean="0">
                          <a:latin typeface="標楷體" panose="03000509000000000000" pitchFamily="65" charset="-12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≦11.0</a:t>
                      </a:r>
                      <a:endParaRPr lang="zh-TW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22" marR="40822" marT="20410" marB="2041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1.63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0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6.15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3.33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  <a:p>
                      <a:pPr algn="l" fontAlgn="t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1.67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1</a:t>
                      </a:r>
                    </a:p>
                    <a:p>
                      <a:pPr algn="l" fontAlgn="b"/>
                      <a:r>
                        <a:rPr lang="en-US" altLang="zh-TW" sz="8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1.00)</a:t>
                      </a:r>
                      <a:endParaRPr lang="en-US" altLang="zh-TW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文字方塊 2"/>
          <p:cNvSpPr txBox="1"/>
          <p:nvPr/>
        </p:nvSpPr>
        <p:spPr>
          <a:xfrm>
            <a:off x="2315019" y="119744"/>
            <a:ext cx="6188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dirty="0"/>
              <a:t>Supplementary </a:t>
            </a:r>
            <a:r>
              <a:rPr lang="en-US" altLang="zh-TW" dirty="0"/>
              <a:t>Table1  </a:t>
            </a:r>
            <a:r>
              <a:rPr lang="en-US" altLang="zh-TW" dirty="0"/>
              <a:t>Population and test characteristics by histologic category in training set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628094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53</TotalTime>
  <Words>377</Words>
  <Application>Microsoft Office PowerPoint</Application>
  <PresentationFormat>如螢幕大小 (4:3)</PresentationFormat>
  <Paragraphs>176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7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9" baseType="lpstr">
      <vt:lpstr>新細明體</vt:lpstr>
      <vt:lpstr>標楷體</vt:lpstr>
      <vt:lpstr>Arial</vt:lpstr>
      <vt:lpstr>Calibri</vt:lpstr>
      <vt:lpstr>Calibri Light</vt:lpstr>
      <vt:lpstr>Symbol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Niall</dc:creator>
  <cp:lastModifiedBy>Yuligh Liou</cp:lastModifiedBy>
  <cp:revision>507</cp:revision>
  <cp:lastPrinted>2015-10-02T08:57:35Z</cp:lastPrinted>
  <dcterms:created xsi:type="dcterms:W3CDTF">2015-07-30T01:53:21Z</dcterms:created>
  <dcterms:modified xsi:type="dcterms:W3CDTF">2016-02-20T15:43:22Z</dcterms:modified>
</cp:coreProperties>
</file>